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906000" type="A4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CC"/>
    <a:srgbClr val="008000"/>
    <a:srgbClr val="009999"/>
    <a:srgbClr val="FF9900"/>
    <a:srgbClr val="33CC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90" d="100"/>
          <a:sy n="90" d="100"/>
        </p:scale>
        <p:origin x="-3726" y="-10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8023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695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1717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36858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626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73075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831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39842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02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670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37998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99C95-D0CE-4776-9395-20C698659C52}" type="datetimeFigureOut">
              <a:rPr lang="en-GB" smtClean="0"/>
              <a:t>12/07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02E77-E2FE-42CB-BCCC-5B3A010283D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26716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8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8930759"/>
              </p:ext>
            </p:extLst>
          </p:nvPr>
        </p:nvGraphicFramePr>
        <p:xfrm>
          <a:off x="261659" y="2072680"/>
          <a:ext cx="3167872" cy="18223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1" name="SPW 10.0 Graph" r:id="rId3" imgW="5324400" imgH="3062160" progId="SigmaPlotGraphicObject.9">
                  <p:embed/>
                </p:oleObj>
              </mc:Choice>
              <mc:Fallback>
                <p:oleObj name="SPW 10.0 Graph" r:id="rId3" imgW="5324400" imgH="3062160" progId="SigmaPlotGraphicObject.9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1659" y="2072680"/>
                        <a:ext cx="3167872" cy="1822384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/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1"/>
          <p:cNvSpPr txBox="1">
            <a:spLocks noChangeArrowheads="1"/>
          </p:cNvSpPr>
          <p:nvPr/>
        </p:nvSpPr>
        <p:spPr bwMode="auto">
          <a:xfrm>
            <a:off x="255010" y="2198488"/>
            <a:ext cx="29367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altLang="en-US" sz="1400" b="1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5" name="TextBox 15"/>
          <p:cNvSpPr txBox="1">
            <a:spLocks noChangeArrowheads="1"/>
          </p:cNvSpPr>
          <p:nvPr/>
        </p:nvSpPr>
        <p:spPr bwMode="auto">
          <a:xfrm>
            <a:off x="473559" y="4160912"/>
            <a:ext cx="2751074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l"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Monoisotopic mass of neutral peptide 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700" baseline="-2500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calc): 962.4974</a:t>
            </a:r>
          </a:p>
          <a:p>
            <a:pPr algn="l"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Fixed modifications: Carbamidomethyl</a:t>
            </a:r>
          </a:p>
          <a:p>
            <a:pPr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Ions score: 45 † 	Expect: 0.011 ‡</a:t>
            </a:r>
          </a:p>
          <a:p>
            <a:pPr algn="l"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Matches 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70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d</a:t>
            </a:r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): 18/50 fragment ions using 44 most intense peaks</a:t>
            </a:r>
          </a:p>
        </p:txBody>
      </p:sp>
      <p:graphicFrame>
        <p:nvGraphicFramePr>
          <p:cNvPr id="6" name="Object 28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1510817"/>
              </p:ext>
            </p:extLst>
          </p:nvPr>
        </p:nvGraphicFramePr>
        <p:xfrm>
          <a:off x="3501539" y="2072680"/>
          <a:ext cx="3167821" cy="1854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2" name="SPW 10.0 Graph" r:id="rId5" imgW="5324400" imgH="3116160" progId="SigmaPlotGraphicObject.9">
                  <p:embed/>
                </p:oleObj>
              </mc:Choice>
              <mc:Fallback>
                <p:oleObj name="SPW 10.0 Graph" r:id="rId5" imgW="5324400" imgH="3116160" progId="SigmaPlotGraphicObject.9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01539" y="2072680"/>
                        <a:ext cx="3167821" cy="1854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1"/>
          <p:cNvSpPr txBox="1">
            <a:spLocks noChangeArrowheads="1"/>
          </p:cNvSpPr>
          <p:nvPr/>
        </p:nvSpPr>
        <p:spPr bwMode="auto">
          <a:xfrm>
            <a:off x="255010" y="4089702"/>
            <a:ext cx="28405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altLang="en-US" sz="1400" b="1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8" name="TextBox 16"/>
          <p:cNvSpPr txBox="1">
            <a:spLocks noChangeArrowheads="1"/>
          </p:cNvSpPr>
          <p:nvPr/>
        </p:nvSpPr>
        <p:spPr bwMode="auto">
          <a:xfrm>
            <a:off x="3685033" y="4160912"/>
            <a:ext cx="2840842" cy="5232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algn="r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l"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Monoisotopic mass of neutral peptide 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GB" sz="700" baseline="-2500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calc): 1547.7984</a:t>
            </a:r>
          </a:p>
          <a:p>
            <a:pPr algn="l"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Fixed modifications: Carbamidomethyl</a:t>
            </a:r>
          </a:p>
          <a:p>
            <a:pPr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Ions score: 55 † 	Expect: 0.0012 ‡</a:t>
            </a:r>
          </a:p>
          <a:p>
            <a:pPr algn="l" eaLnBrk="1" hangingPunct="1"/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Matches 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70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): </a:t>
            </a:r>
            <a:r>
              <a:rPr lang="en-GB" sz="700" smtClean="0">
                <a:latin typeface="Arial" panose="020B0604020202020204" pitchFamily="34" charset="0"/>
                <a:cs typeface="Arial" panose="020B0604020202020204" pitchFamily="34" charset="0"/>
              </a:rPr>
              <a:t>29/98 </a:t>
            </a:r>
            <a:r>
              <a:rPr lang="en-GB" sz="700">
                <a:latin typeface="Arial" panose="020B0604020202020204" pitchFamily="34" charset="0"/>
                <a:cs typeface="Arial" panose="020B0604020202020204" pitchFamily="34" charset="0"/>
              </a:rPr>
              <a:t>fragment ions using 60 most intense peaks</a:t>
            </a: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3707400"/>
              </p:ext>
            </p:extLst>
          </p:nvPr>
        </p:nvGraphicFramePr>
        <p:xfrm>
          <a:off x="390770" y="4746165"/>
          <a:ext cx="2909651" cy="1259997"/>
        </p:xfrm>
        <a:graphic>
          <a:graphicData uri="http://schemas.openxmlformats.org/drawingml/2006/table">
            <a:tbl>
              <a:tblPr firstRow="1" firstCol="1" bandRow="1"/>
              <a:tblGrid>
                <a:gridCol w="95101"/>
                <a:gridCol w="317135"/>
                <a:gridCol w="303970"/>
                <a:gridCol w="318919"/>
                <a:gridCol w="321410"/>
                <a:gridCol w="179222"/>
                <a:gridCol w="300034"/>
                <a:gridCol w="311444"/>
                <a:gridCol w="311445"/>
                <a:gridCol w="341342"/>
                <a:gridCol w="109629"/>
              </a:tblGrid>
              <a:tr h="13838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#</a:t>
                      </a:r>
                      <a:endParaRPr lang="en-GB" sz="600" b="1" dirty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*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*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eq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*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*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#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023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14.091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7.549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L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023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277.154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39.081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Y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850.420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425.713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33.394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17.200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023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74.207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87.607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P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87.357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344.182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70.330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335.669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38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88.250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44.628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71.223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36.115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N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590.304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95.655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573.278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87.142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38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545.271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73.139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28.245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64.626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G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476.261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38.634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59.235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30.121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38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92.340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346.673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75.313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38.160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F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419.240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10.123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02.213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01.610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838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789.393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95.200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72.366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86.686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P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272.171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36.589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55.145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8.076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42023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 dirty="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 dirty="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R</a:t>
                      </a:r>
                      <a:endParaRPr lang="en-GB" sz="600"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75.119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8.063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58.092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9.549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</a:t>
                      </a:r>
                      <a:endParaRPr lang="en-GB" sz="600" b="1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graphicFrame>
        <p:nvGraphicFramePr>
          <p:cNvPr id="10" name="Tab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9730397"/>
              </p:ext>
            </p:extLst>
          </p:nvPr>
        </p:nvGraphicFramePr>
        <p:xfrm>
          <a:off x="3605577" y="4746165"/>
          <a:ext cx="2959745" cy="2079043"/>
        </p:xfrm>
        <a:graphic>
          <a:graphicData uri="http://schemas.openxmlformats.org/drawingml/2006/table">
            <a:tbl>
              <a:tblPr firstRow="1" firstCol="1" bandRow="1"/>
              <a:tblGrid>
                <a:gridCol w="88900"/>
                <a:gridCol w="311001"/>
                <a:gridCol w="314325"/>
                <a:gridCol w="340519"/>
                <a:gridCol w="321468"/>
                <a:gridCol w="160338"/>
                <a:gridCol w="332581"/>
                <a:gridCol w="319088"/>
                <a:gridCol w="335756"/>
                <a:gridCol w="328612"/>
                <a:gridCol w="107157"/>
              </a:tblGrid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#</a:t>
                      </a:r>
                      <a:endParaRPr lang="en-GB" sz="600" b="1" dirty="0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*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b*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Seq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*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y*</a:t>
                      </a:r>
                      <a:r>
                        <a:rPr lang="en-GB" sz="600" b="1" baseline="30000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++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" pitchFamily="34" charset="0"/>
                          <a:ea typeface="Times New Roman"/>
                          <a:cs typeface="Arial" pitchFamily="34" charset="0"/>
                        </a:rPr>
                        <a:t>#</a:t>
                      </a:r>
                      <a:endParaRPr lang="en-GB" sz="600" b="1">
                        <a:effectLst/>
                        <a:latin typeface="Arial" pitchFamily="34" charset="0"/>
                        <a:ea typeface="Times New Roman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5954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8.039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4.523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S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4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5954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235.107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18.057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F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461.773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31.390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444.747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22.877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3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5954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332.160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66.583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P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314.705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57.856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97.678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49.343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46.203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23.605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29.176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15.092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N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217.652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09.329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00.625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00.816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1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60.246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280.626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43.219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72.113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N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103.609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52.308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086.583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543.795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0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89.288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45.148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72.262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36.634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E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989.566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95.286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972.540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86.773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9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760.326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80.666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743.299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72.153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A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860.524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30.765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43.497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22.252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8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873.410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37.208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856.383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28.695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I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789.486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95.247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72.460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86.733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9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930.431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65.719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913.405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57.206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G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76.402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38.705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59.376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30.191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0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029.500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515.253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012.473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06.740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V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619.381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10.194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02.354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01.681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1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126.552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63.780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109 526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55.266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P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520.313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260.660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503.286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52.146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289.616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45.311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72.589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36.798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Y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23.2602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12.133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406.233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03.6205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3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30989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3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1402.700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01.8537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385.6736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93.3404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L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FF0000"/>
                          </a:solidFill>
                          <a:effectLst/>
                          <a:latin typeface="Arial Narrow"/>
                          <a:ea typeface="Times New Roman"/>
                        </a:rPr>
                        <a:t>260.1969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30.6021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43.170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22.088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2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159541">
                <a:tc>
                  <a:txBody>
                    <a:bodyPr/>
                    <a:lstStyle/>
                    <a:p>
                      <a:pPr algn="l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4</a:t>
                      </a:r>
                      <a:endParaRPr lang="en-GB" sz="600" b="1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/>
                      <a:endParaRPr lang="en-GB" sz="600">
                        <a:effectLst/>
                        <a:latin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>
                          <a:solidFill>
                            <a:schemeClr val="tx1"/>
                          </a:solidFill>
                          <a:effectLst/>
                          <a:latin typeface="Verdana" pitchFamily="34" charset="0"/>
                          <a:ea typeface="Verdana" pitchFamily="34" charset="0"/>
                          <a:cs typeface="Verdana" pitchFamily="34" charset="0"/>
                        </a:rPr>
                        <a:t>K</a:t>
                      </a:r>
                      <a:endParaRPr lang="en-GB" sz="600">
                        <a:solidFill>
                          <a:schemeClr val="tx1"/>
                        </a:solidFill>
                        <a:effectLst/>
                        <a:latin typeface="Verdana" pitchFamily="34" charset="0"/>
                        <a:ea typeface="Verdana" pitchFamily="34" charset="0"/>
                        <a:cs typeface="Verdana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47.1128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74.0600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30.0863</a:t>
                      </a:r>
                      <a:endParaRPr lang="en-GB" sz="60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dirty="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65.5468</a:t>
                      </a:r>
                      <a:endParaRPr lang="en-GB" sz="600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ts val="800"/>
                        </a:lnSpc>
                        <a:spcAft>
                          <a:spcPts val="0"/>
                        </a:spcAft>
                      </a:pPr>
                      <a:r>
                        <a:rPr lang="en-GB" sz="600" b="1" dirty="0">
                          <a:solidFill>
                            <a:srgbClr val="000000"/>
                          </a:solidFill>
                          <a:effectLst/>
                          <a:latin typeface="Arial Narrow"/>
                          <a:ea typeface="Times New Roman"/>
                        </a:rPr>
                        <a:t>1</a:t>
                      </a:r>
                      <a:endParaRPr lang="en-GB" sz="600" b="1" dirty="0">
                        <a:effectLst/>
                        <a:latin typeface="Times New Roman"/>
                        <a:ea typeface="Times New Roman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2" name="Rectangle 11"/>
          <p:cNvSpPr/>
          <p:nvPr/>
        </p:nvSpPr>
        <p:spPr>
          <a:xfrm>
            <a:off x="260648" y="6997094"/>
            <a:ext cx="6408712" cy="24160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GB" sz="900" b="1">
                <a:latin typeface="Century Schoolbook" panose="02040604050505020304" pitchFamily="18" charset="0"/>
                <a:ea typeface="Times New Roman" panose="02020603050405020304" pitchFamily="18" charset="0"/>
              </a:rPr>
              <a:t>Fig. S2. 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ss spectra </a:t>
            </a:r>
            <a:r>
              <a:rPr lang="en-GB" sz="90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tryptic peptides 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GB" sz="900" i="1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quisetum fluviatile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TG.</a:t>
            </a:r>
            <a:endParaRPr lang="en-GB" sz="900" b="1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pPr lvl="0">
              <a:spcAft>
                <a:spcPts val="600"/>
              </a:spcAft>
            </a:pP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GB" sz="90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LDI–ToF mass spectrum of 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act tryptic peptides from </a:t>
            </a:r>
            <a:r>
              <a:rPr lang="en-GB" sz="90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EF/SDS-purified 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TG (see Fig, 2e). The two peaks labelled in blue have m/z values corresponding to tryptic peptides </a:t>
            </a:r>
            <a:r>
              <a:rPr lang="en-GB" sz="90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dicted 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 an XTH-related nucleotide sequence found in the </a:t>
            </a:r>
            <a:r>
              <a:rPr lang="en-GB" sz="900" i="1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quisetum</a:t>
            </a:r>
            <a:r>
              <a:rPr lang="en-GB" sz="900" smtClean="0">
                <a:solidFill>
                  <a:prstClr val="black"/>
                </a:solidFill>
                <a:latin typeface="Century Schoolbook" panose="020406040505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anscriptome.</a:t>
            </a:r>
            <a:endParaRPr lang="en-GB" sz="900">
              <a:solidFill>
                <a:prstClr val="black"/>
              </a:solidFill>
              <a:latin typeface="Century Schoolbook" panose="020406040505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(b) LC–MS/MS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fragmentation spectra of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the two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tryptic peptides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highlighted in (a), whose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doubly-charged parent ions had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/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z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482.26 and 774.91 respectively. Each spectrum identifies a different partial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XTH-homologue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mRNA found in th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Equisetu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transcriptome. </a:t>
            </a:r>
            <a:endParaRPr lang="en-GB" sz="900" smtClean="0">
              <a:latin typeface="Century Schoolbook" panose="02040604050505020304" pitchFamily="18" charset="0"/>
              <a:ea typeface="Times New Roman" panose="02020603050405020304" pitchFamily="18" charset="0"/>
            </a:endParaRPr>
          </a:p>
          <a:p>
            <a:pPr>
              <a:spcAft>
                <a:spcPts val="600"/>
              </a:spcAft>
            </a:pP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(c)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The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corresponding putative amino acid sequences taken from a MASCOT 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search;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the 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m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/</a:t>
            </a:r>
            <a:r>
              <a:rPr lang="en-GB" sz="900" i="1">
                <a:latin typeface="Century Schoolbook" panose="02040604050505020304" pitchFamily="18" charset="0"/>
                <a:ea typeface="Times New Roman" panose="02020603050405020304" pitchFamily="18" charset="0"/>
              </a:rPr>
              <a:t>z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 values of detected positive ion fragments are in red. The ‘b’ and ‘y’ ions are singly charged fragments (molecule + 1 H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) produced by fragmentation from the N- and C-terminus respectively; ‘b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’ and ‘y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’ ions are the corresponding doubly charged fragments (molecule + 2 H</a:t>
            </a:r>
            <a:r>
              <a:rPr lang="en-GB" sz="900" baseline="30000">
                <a:latin typeface="Century Schoolbook" panose="02040604050505020304" pitchFamily="18" charset="0"/>
                <a:ea typeface="Times New Roman" panose="02020603050405020304" pitchFamily="18" charset="0"/>
              </a:rPr>
              <a:t>+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). The y* ions are y ions with loss of water. Fragmentation spectra matching two further </a:t>
            </a:r>
            <a:r>
              <a:rPr lang="en-GB" sz="900" i="1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in-silico</a:t>
            </a:r>
            <a:r>
              <a:rPr lang="en-GB" sz="9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 </a:t>
            </a:r>
            <a:r>
              <a:rPr lang="en-GB" sz="900">
                <a:latin typeface="Century Schoolbook" panose="02040604050505020304" pitchFamily="18" charset="0"/>
                <a:ea typeface="Times New Roman" panose="02020603050405020304" pitchFamily="18" charset="0"/>
              </a:rPr>
              <a:t>peptides (ENYLK and ENYLKYDYCYDTK) from HTG partial transcriptome sequences were also identified. </a:t>
            </a:r>
          </a:p>
          <a:p>
            <a:pPr>
              <a:spcAft>
                <a:spcPts val="600"/>
              </a:spcAft>
            </a:pP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† For explanation, see http://www.matrixscience.com/help/interpretation_help.html</a:t>
            </a:r>
          </a:p>
          <a:p>
            <a:pPr>
              <a:spcAft>
                <a:spcPts val="600"/>
              </a:spcAft>
            </a:pPr>
            <a:r>
              <a:rPr lang="en-GB" sz="800">
                <a:latin typeface="Century Schoolbook" panose="02040604050505020304" pitchFamily="18" charset="0"/>
                <a:ea typeface="Times New Roman" panose="02020603050405020304" pitchFamily="18" charset="0"/>
              </a:rPr>
              <a:t>‡ For explanation, see http://</a:t>
            </a:r>
            <a:r>
              <a:rPr lang="en-GB" sz="800" smtClean="0">
                <a:latin typeface="Century Schoolbook" panose="02040604050505020304" pitchFamily="18" charset="0"/>
                <a:ea typeface="Times New Roman" panose="02020603050405020304" pitchFamily="18" charset="0"/>
              </a:rPr>
              <a:t>www.matrixscience.com/help/scoring_help.html</a:t>
            </a:r>
            <a:endParaRPr lang="en-GB" sz="800">
              <a:latin typeface="Century Schoolbook" panose="02040604050505020304" pitchFamily="18" charset="0"/>
              <a:ea typeface="Times New Roman" panose="02020603050405020304" pitchFamily="18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476672" y="200472"/>
            <a:ext cx="5940000" cy="2000625"/>
            <a:chOff x="363100" y="5616671"/>
            <a:chExt cx="5940000" cy="2000625"/>
          </a:xfrm>
        </p:grpSpPr>
        <p:graphicFrame>
          <p:nvGraphicFramePr>
            <p:cNvPr id="14" name="Object 1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34302836"/>
                </p:ext>
              </p:extLst>
            </p:nvPr>
          </p:nvGraphicFramePr>
          <p:xfrm>
            <a:off x="363100" y="5616671"/>
            <a:ext cx="5940000" cy="20006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243" name="SPW 12.0 Graph" r:id="rId7" imgW="13362390" imgH="4500506" progId="SigmaPlotGraphicObject.11">
                    <p:embed/>
                  </p:oleObj>
                </mc:Choice>
                <mc:Fallback>
                  <p:oleObj name="SPW 12.0 Graph" r:id="rId7" imgW="13362390" imgH="4500506" progId="SigmaPlotGraphicObject.11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63100" y="5616671"/>
                          <a:ext cx="5940000" cy="20006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 rot="16200000">
              <a:off x="2156172" y="6003133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b="1" smtClean="0">
                  <a:solidFill>
                    <a:srgbClr val="0000FF"/>
                  </a:solidFill>
                  <a:latin typeface="Arial" pitchFamily="34" charset="0"/>
                  <a:cs typeface="Arial" pitchFamily="34" charset="0"/>
                </a:rPr>
                <a:t>963.43</a:t>
              </a:r>
              <a:endParaRPr lang="en-GB" sz="900" b="1">
                <a:solidFill>
                  <a:srgbClr val="00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2270045" y="6768606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964.43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752117" y="6768606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861.02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1661926" y="6651205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842.46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871695" y="6651205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656.03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778783" y="6579197"/>
              <a:ext cx="35266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650.02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4828309" y="6722246"/>
              <a:ext cx="41678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b="1" smtClean="0">
                  <a:solidFill>
                    <a:srgbClr val="0000FF"/>
                  </a:solidFill>
                  <a:latin typeface="Arial" pitchFamily="34" charset="0"/>
                  <a:cs typeface="Arial" pitchFamily="34" charset="0"/>
                </a:rPr>
                <a:t>1548.59</a:t>
              </a:r>
              <a:endParaRPr lang="en-GB" sz="900" b="1">
                <a:solidFill>
                  <a:srgbClr val="0000FF"/>
                </a:solidFill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4503981" y="6892877"/>
              <a:ext cx="41678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1475.60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5852147" y="6820869"/>
              <a:ext cx="416781" cy="138499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900" smtClean="0">
                  <a:latin typeface="Arial" pitchFamily="34" charset="0"/>
                  <a:cs typeface="Arial" pitchFamily="34" charset="0"/>
                </a:rPr>
                <a:t>1774.52</a:t>
              </a:r>
              <a:endParaRPr lang="en-GB" sz="9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2699059" y="5976711"/>
              <a:ext cx="864339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smtClean="0">
                  <a:solidFill>
                    <a:srgbClr val="0000FF"/>
                  </a:solidFill>
                  <a:latin typeface="Courier New" pitchFamily="49" charset="0"/>
                  <a:cs typeface="Courier New" pitchFamily="49" charset="0"/>
                </a:rPr>
                <a:t>LYPNGFPR</a:t>
              </a:r>
              <a:endParaRPr lang="en-GB" sz="1100">
                <a:solidFill>
                  <a:srgbClr val="0000FF"/>
                </a:solidFill>
                <a:latin typeface="Courier New" pitchFamily="49" charset="0"/>
                <a:cs typeface="Courier New" pitchFamily="49" charset="0"/>
              </a:endParaRP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4183212" y="5976711"/>
              <a:ext cx="1374094" cy="2616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1100" smtClean="0">
                  <a:solidFill>
                    <a:srgbClr val="0000FF"/>
                  </a:solidFill>
                  <a:latin typeface="Courier New" pitchFamily="49" charset="0"/>
                  <a:cs typeface="Courier New" pitchFamily="49" charset="0"/>
                </a:rPr>
                <a:t>SFPNNEAIGVPYLK</a:t>
              </a:r>
              <a:endParaRPr lang="en-GB" sz="1100">
                <a:solidFill>
                  <a:srgbClr val="0000FF"/>
                </a:solidFill>
                <a:latin typeface="Courier New" pitchFamily="49" charset="0"/>
                <a:cs typeface="Courier New" pitchFamily="49" charset="0"/>
              </a:endParaRP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 flipH="1">
              <a:off x="2394057" y="6099821"/>
              <a:ext cx="305002" cy="0"/>
            </a:xfrm>
            <a:prstGeom prst="straightConnector1">
              <a:avLst/>
            </a:prstGeom>
            <a:ln w="1270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5026431" y="6222932"/>
              <a:ext cx="0" cy="329843"/>
            </a:xfrm>
            <a:prstGeom prst="straightConnector1">
              <a:avLst/>
            </a:prstGeom>
            <a:ln w="12700">
              <a:solidFill>
                <a:srgbClr val="0000FF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TextBox 27"/>
          <p:cNvSpPr txBox="1"/>
          <p:nvPr/>
        </p:nvSpPr>
        <p:spPr>
          <a:xfrm>
            <a:off x="255010" y="44153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9" name="TextBox 28"/>
          <p:cNvSpPr txBox="1"/>
          <p:nvPr/>
        </p:nvSpPr>
        <p:spPr>
          <a:xfrm rot="16200000">
            <a:off x="-23099" y="1069582"/>
            <a:ext cx="1209406" cy="160069"/>
          </a:xfrm>
          <a:prstGeom prst="rect">
            <a:avLst/>
          </a:prstGeom>
          <a:solidFill>
            <a:schemeClr val="bg1"/>
          </a:solidFill>
        </p:spPr>
        <p:txBody>
          <a:bodyPr wrap="square" lIns="72000" tIns="36000" rIns="72000" bIns="18000" rtlCol="0">
            <a:spAutoFit/>
          </a:bodyPr>
          <a:lstStyle/>
          <a:p>
            <a:pPr algn="ctr">
              <a:lnSpc>
                <a:spcPts val="800"/>
              </a:lnSpc>
            </a:pPr>
            <a:r>
              <a:rPr lang="en-GB" sz="1000" smtClean="0">
                <a:latin typeface="Arial Narrow" panose="020B0606020202030204" pitchFamily="34" charset="0"/>
              </a:rPr>
              <a:t>Intensity</a:t>
            </a:r>
            <a:endParaRPr lang="en-GB" sz="1000">
              <a:latin typeface="Arial Narrow" panose="020B060602020203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661248" y="128464"/>
            <a:ext cx="686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smtClean="0">
                <a:latin typeface="Century Schoolbook" panose="02040604050505020304" pitchFamily="18" charset="0"/>
              </a:rPr>
              <a:t>Fig. S2</a:t>
            </a:r>
            <a:endParaRPr lang="en-GB" sz="1200">
              <a:latin typeface="Century Schoolbook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5893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93</TotalTime>
  <Words>529</Words>
  <Application>Microsoft Office PowerPoint</Application>
  <PresentationFormat>A4 Paper (210x297 mm)</PresentationFormat>
  <Paragraphs>266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Office Theme</vt:lpstr>
      <vt:lpstr>SPW 10.0 Graph</vt:lpstr>
      <vt:lpstr>SPW 12.0 Graph</vt:lpstr>
      <vt:lpstr>PowerPoint Presentation</vt:lpstr>
    </vt:vector>
  </TitlesOfParts>
  <Company>University of Edinburg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Y Stephen</dc:creator>
  <cp:lastModifiedBy>Steve Fry</cp:lastModifiedBy>
  <cp:revision>95</cp:revision>
  <cp:lastPrinted>2015-03-02T19:14:39Z</cp:lastPrinted>
  <dcterms:created xsi:type="dcterms:W3CDTF">2014-10-24T13:36:09Z</dcterms:created>
  <dcterms:modified xsi:type="dcterms:W3CDTF">2015-07-12T20:25:46Z</dcterms:modified>
</cp:coreProperties>
</file>